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6" d="100"/>
          <a:sy n="46" d="100"/>
        </p:scale>
        <p:origin x="2837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76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2891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03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43729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053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992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394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463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297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859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99680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0AF59-483E-4DCD-8F42-15C46682119F}" type="datetimeFigureOut">
              <a:rPr lang="en-GB" smtClean="0"/>
              <a:t>14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D7309-7FCA-4143-A8BF-5743F7C4781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7160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6A7161F7-9E0F-4096-A6CC-90B6F88AA0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8184" y="0"/>
            <a:ext cx="5641631" cy="5342022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AAB09A45-A942-4339-B97A-798B440DE0EE}"/>
              </a:ext>
            </a:extLst>
          </p:cNvPr>
          <p:cNvSpPr/>
          <p:nvPr/>
        </p:nvSpPr>
        <p:spPr>
          <a:xfrm>
            <a:off x="0" y="5342022"/>
            <a:ext cx="68580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hu-HU" sz="1200" b="1" dirty="0">
                <a:latin typeface="Segoe UI" panose="020B0502040204020203" pitchFamily="34" charset="0"/>
                <a:ea typeface="Calibri" panose="020F0502020204030204" pitchFamily="34" charset="0"/>
              </a:rPr>
              <a:t>Figure S2.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 Determination of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Cas9 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copy number by hygromycin segregation test on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cslf6-2/+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 (heterozygous) mutant seedlings from T</a:t>
            </a:r>
            <a:r>
              <a:rPr lang="hu-HU" sz="1200" baseline="-25000" dirty="0">
                <a:latin typeface="Segoe UI" panose="020B0502040204020203" pitchFamily="34" charset="0"/>
                <a:ea typeface="Calibri" panose="020F0502020204030204" pitchFamily="34" charset="0"/>
              </a:rPr>
              <a:t>2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. In total 20 seed were grown on Agargel with Hygromycin (100 µg/mL) for two weeks at RT. Seedlings were score for hygromycin sensitivity/resistance. (a)</a:t>
            </a:r>
            <a:r>
              <a:rPr lang="hu-HU" sz="1200" b="1" dirty="0">
                <a:latin typeface="Segoe UI" panose="020B0502040204020203" pitchFamily="34" charset="0"/>
                <a:ea typeface="Calibri" panose="020F0502020204030204" pitchFamily="34" charset="0"/>
              </a:rPr>
              <a:t> 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Phenotype of a sensitive (left) and resistant (right) seedlings. (b) Phenotype of 20 seedlings from the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cslf6-2/+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 (heterozygous) line. (c) Chi square test for hygromycin segregation. The null hypothesis (H°, 1 d.f.) of a single copy </a:t>
            </a:r>
            <a:r>
              <a:rPr lang="hu-HU" sz="1200" i="1" dirty="0">
                <a:latin typeface="Segoe UI" panose="020B0502040204020203" pitchFamily="34" charset="0"/>
                <a:ea typeface="Calibri" panose="020F0502020204030204" pitchFamily="34" charset="0"/>
              </a:rPr>
              <a:t>Cas9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 insertion, 3:1 resistant (R) vs sensitive (S) segregation, was rejected (</a:t>
            </a:r>
            <a:r>
              <a:rPr lang="hu-HU" sz="1200" dirty="0">
                <a:solidFill>
                  <a:srgbClr val="000000"/>
                </a:solidFill>
                <a:latin typeface="Segoe UI" panose="020B0502040204020203" pitchFamily="34" charset="0"/>
                <a:ea typeface="Times New Roman" panose="02020603050405020304" pitchFamily="18" charset="0"/>
              </a:rPr>
              <a:t>p = 0.011)</a:t>
            </a:r>
            <a:r>
              <a:rPr lang="hu-HU" sz="1200" dirty="0">
                <a:latin typeface="Segoe UI" panose="020B0502040204020203" pitchFamily="34" charset="0"/>
                <a:ea typeface="Calibri" panose="020F0502020204030204" pitchFamily="34" charset="0"/>
              </a:rPr>
              <a:t>. The suspected hygromycin sensitive genotype died before transplanting them to soil.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5694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14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illermo Garcia</dc:creator>
  <cp:lastModifiedBy>Guillermo Garcia</cp:lastModifiedBy>
  <cp:revision>9</cp:revision>
  <dcterms:created xsi:type="dcterms:W3CDTF">2020-05-14T00:51:09Z</dcterms:created>
  <dcterms:modified xsi:type="dcterms:W3CDTF">2020-05-14T01:33:05Z</dcterms:modified>
</cp:coreProperties>
</file>